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34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166CC6-5ED9-4C6F-BFB9-8099A4A45B0E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385CBD-B5F9-40DF-82BD-9CE04B1CD6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376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D783E5-C4FD-4368-AA52-5A218A2CC376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9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87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168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688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01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148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603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700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752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544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807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50BD8-BCD6-499C-98EE-287FCB401B9A}" type="datetimeFigureOut">
              <a:rPr lang="en-US" smtClean="0"/>
              <a:t>5/1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7FF5D-BC0E-49E6-B7D9-A32257B656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29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5004048" y="-72033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(a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284901" y="0"/>
            <a:ext cx="772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(a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1" name="表格 30"/>
          <p:cNvGraphicFramePr>
            <a:graphicFrameLocks noGrp="1"/>
          </p:cNvGraphicFramePr>
          <p:nvPr/>
        </p:nvGraphicFramePr>
        <p:xfrm>
          <a:off x="5076056" y="332631"/>
          <a:ext cx="3722689" cy="1800225"/>
        </p:xfrm>
        <a:graphic>
          <a:graphicData uri="http://schemas.openxmlformats.org/drawingml/2006/table">
            <a:tbl>
              <a:tblPr/>
              <a:tblGrid>
                <a:gridCol w="250825"/>
                <a:gridCol w="1531938"/>
                <a:gridCol w="1462088"/>
                <a:gridCol w="477838"/>
              </a:tblGrid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.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ft</a:t>
                      </a:r>
                      <a:r>
                        <a:rPr lang="en-US" sz="1000" b="1" i="0" u="none" strike="noStrike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ight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ngt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339_length_192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631_length_28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225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898_length_1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79_length_694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456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255_length_8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100_length_2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431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322_length_1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401_length_1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63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401_length_1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909_length_10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73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322_length_1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909_length_10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495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322_length_1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909_length_10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49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403_length_543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215_length_935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782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609_length_10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219_length_686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00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842793" y="44624"/>
            <a:ext cx="2765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M    1    2     3    4    5    6     7    8     9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04048" y="2276872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(b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1" name="表格 10"/>
          <p:cNvGraphicFramePr>
            <a:graphicFrameLocks noGrp="1"/>
          </p:cNvGraphicFramePr>
          <p:nvPr/>
        </p:nvGraphicFramePr>
        <p:xfrm>
          <a:off x="5076056" y="2636912"/>
          <a:ext cx="3744416" cy="1440902"/>
        </p:xfrm>
        <a:graphic>
          <a:graphicData uri="http://schemas.openxmlformats.org/drawingml/2006/table">
            <a:tbl>
              <a:tblPr/>
              <a:tblGrid>
                <a:gridCol w="258763"/>
                <a:gridCol w="1462088"/>
                <a:gridCol w="1519509"/>
                <a:gridCol w="504056"/>
              </a:tblGrid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.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ft</a:t>
                      </a:r>
                      <a:r>
                        <a:rPr lang="en-US" sz="1000" b="1" i="0" u="none" strike="noStrike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ight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ngth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534_length_1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527_length_1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2042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2533_length_1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52_length_1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495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656_length_18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798_length_8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49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798_length_8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615_length_1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676_length_26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184_length_3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084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1184_length_31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468_length_1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674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360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2377_length_1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ODE_628_length_11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kern="1200" dirty="0" smtClean="0">
                          <a:solidFill>
                            <a:schemeClr val="tx1"/>
                          </a:solidFill>
                          <a:latin typeface="Arial" pitchFamily="34" charset="0"/>
                          <a:ea typeface="+mn-ea"/>
                          <a:cs typeface="Arial" pitchFamily="34" charset="0"/>
                        </a:rPr>
                        <a:t>796</a:t>
                      </a:r>
                      <a:endParaRPr lang="en-US" sz="1000" b="0" i="0" u="none" strike="noStrike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1285806" y="2132856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(b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220072" y="6488668"/>
            <a:ext cx="2339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Template: BJAB0715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894384" y="2132856"/>
            <a:ext cx="26805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M     1      2      3     4    5      6      7 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83568" y="1035224"/>
            <a:ext cx="61453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85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65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3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直接箭头连接符 18"/>
          <p:cNvCxnSpPr/>
          <p:nvPr/>
        </p:nvCxnSpPr>
        <p:spPr>
          <a:xfrm>
            <a:off x="1221904" y="1873424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>
            <a:off x="1221904" y="1797224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>
            <a:off x="1221904" y="1701269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>
            <a:off x="1221904" y="1625069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>
            <a:off x="1221904" y="1568624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/>
        </p:nvCxnSpPr>
        <p:spPr>
          <a:xfrm>
            <a:off x="1221904" y="1492424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>
            <a:off x="1221904" y="1416224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箭头连接符 27"/>
          <p:cNvCxnSpPr/>
          <p:nvPr/>
        </p:nvCxnSpPr>
        <p:spPr>
          <a:xfrm>
            <a:off x="1221904" y="1340024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683568" y="3184394"/>
            <a:ext cx="60121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85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65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3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" name="直接箭头连接符 31"/>
          <p:cNvCxnSpPr/>
          <p:nvPr/>
        </p:nvCxnSpPr>
        <p:spPr>
          <a:xfrm>
            <a:off x="1208584" y="4022594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/>
          <p:cNvCxnSpPr/>
          <p:nvPr/>
        </p:nvCxnSpPr>
        <p:spPr>
          <a:xfrm>
            <a:off x="1208584" y="3926201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接箭头连接符 33"/>
          <p:cNvCxnSpPr/>
          <p:nvPr/>
        </p:nvCxnSpPr>
        <p:spPr>
          <a:xfrm>
            <a:off x="1208584" y="3853262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/>
          <p:cNvCxnSpPr/>
          <p:nvPr/>
        </p:nvCxnSpPr>
        <p:spPr>
          <a:xfrm>
            <a:off x="1208584" y="3777062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/>
          <p:cNvCxnSpPr/>
          <p:nvPr/>
        </p:nvCxnSpPr>
        <p:spPr>
          <a:xfrm>
            <a:off x="1208584" y="3686750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/>
          <p:cNvCxnSpPr/>
          <p:nvPr/>
        </p:nvCxnSpPr>
        <p:spPr>
          <a:xfrm>
            <a:off x="1208584" y="3621839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/>
          <p:cNvCxnSpPr/>
          <p:nvPr/>
        </p:nvCxnSpPr>
        <p:spPr>
          <a:xfrm>
            <a:off x="1208584" y="3556928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/>
          <p:cNvCxnSpPr/>
          <p:nvPr/>
        </p:nvCxnSpPr>
        <p:spPr>
          <a:xfrm>
            <a:off x="1208584" y="3480728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907704" y="261057"/>
            <a:ext cx="2651760" cy="18494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894384" y="2361456"/>
            <a:ext cx="2560320" cy="2010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1" name="TextBox 40"/>
          <p:cNvSpPr txBox="1"/>
          <p:nvPr/>
        </p:nvSpPr>
        <p:spPr>
          <a:xfrm>
            <a:off x="-36512" y="-27384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Figure S5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076056" y="4293096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(c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2" name="表格 10"/>
          <p:cNvGraphicFramePr>
            <a:graphicFrameLocks noGrp="1"/>
          </p:cNvGraphicFramePr>
          <p:nvPr/>
        </p:nvGraphicFramePr>
        <p:xfrm>
          <a:off x="5076056" y="4653136"/>
          <a:ext cx="2677923" cy="1807386"/>
        </p:xfrm>
        <a:graphic>
          <a:graphicData uri="http://schemas.openxmlformats.org/drawingml/2006/table">
            <a:tbl>
              <a:tblPr/>
              <a:tblGrid>
                <a:gridCol w="258763"/>
                <a:gridCol w="906992"/>
                <a:gridCol w="936104"/>
                <a:gridCol w="576064"/>
              </a:tblGrid>
              <a:tr h="17145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.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Left</a:t>
                      </a:r>
                      <a:r>
                        <a:rPr lang="en-US" sz="1000" b="1" i="0" u="none" strike="noStrike" baseline="0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Right primer</a:t>
                      </a:r>
                      <a:endParaRPr lang="en-US" sz="1000" b="1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Length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22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22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22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52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22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03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75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22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75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52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1368</a:t>
                      </a:r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75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03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360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216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225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550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216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528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2169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NODE_1030</a:t>
                      </a:r>
                    </a:p>
                  </a:txBody>
                  <a:tcPr marL="7620" marR="7620" marT="762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zh-CN" sz="1000" b="0" i="0" u="none" strike="noStrike" dirty="0">
                        <a:solidFill>
                          <a:schemeClr val="tx1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46" name="Picture 3" descr="C:\Users\Lingxiang Zhu\Downloads\0505 pcr for 301 DNA-1.tif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1905000" y="4679428"/>
            <a:ext cx="2651760" cy="1804800"/>
          </a:xfrm>
          <a:prstGeom prst="rect">
            <a:avLst/>
          </a:prstGeom>
          <a:noFill/>
        </p:spPr>
      </p:pic>
      <p:sp>
        <p:nvSpPr>
          <p:cNvPr id="47" name="TextBox 46"/>
          <p:cNvSpPr txBox="1"/>
          <p:nvPr/>
        </p:nvSpPr>
        <p:spPr>
          <a:xfrm>
            <a:off x="1979624" y="4450828"/>
            <a:ext cx="2592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M    1    2    3    4     5    6   7   8    9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11560" y="5073748"/>
            <a:ext cx="67692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85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65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4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3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200</a:t>
            </a:r>
          </a:p>
          <a:p>
            <a:pPr algn="r"/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100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0" name="直接箭头连接符 18"/>
          <p:cNvCxnSpPr/>
          <p:nvPr/>
        </p:nvCxnSpPr>
        <p:spPr>
          <a:xfrm>
            <a:off x="1212280" y="5946024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箭头连接符 21"/>
          <p:cNvCxnSpPr/>
          <p:nvPr/>
        </p:nvCxnSpPr>
        <p:spPr>
          <a:xfrm>
            <a:off x="1212280" y="5835748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箭头连接符 22"/>
          <p:cNvCxnSpPr/>
          <p:nvPr/>
        </p:nvCxnSpPr>
        <p:spPr>
          <a:xfrm>
            <a:off x="1212280" y="5739793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直接箭头连接符 23"/>
          <p:cNvCxnSpPr/>
          <p:nvPr/>
        </p:nvCxnSpPr>
        <p:spPr>
          <a:xfrm>
            <a:off x="1212280" y="5663593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箭头连接符 24"/>
          <p:cNvCxnSpPr/>
          <p:nvPr/>
        </p:nvCxnSpPr>
        <p:spPr>
          <a:xfrm>
            <a:off x="1212280" y="5607148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接箭头连接符 25"/>
          <p:cNvCxnSpPr/>
          <p:nvPr/>
        </p:nvCxnSpPr>
        <p:spPr>
          <a:xfrm>
            <a:off x="1212280" y="5530948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箭头连接符 26"/>
          <p:cNvCxnSpPr/>
          <p:nvPr/>
        </p:nvCxnSpPr>
        <p:spPr>
          <a:xfrm>
            <a:off x="1212280" y="5454748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箭头连接符 27"/>
          <p:cNvCxnSpPr/>
          <p:nvPr/>
        </p:nvCxnSpPr>
        <p:spPr>
          <a:xfrm>
            <a:off x="1212280" y="5378548"/>
            <a:ext cx="685800" cy="158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1298630" y="4392853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Arial" pitchFamily="34" charset="0"/>
                <a:cs typeface="Arial" pitchFamily="34" charset="0"/>
              </a:rPr>
              <a:t>(c)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37969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85</Words>
  <Application>Microsoft Office PowerPoint</Application>
  <PresentationFormat>On-screen Show (4:3)</PresentationFormat>
  <Paragraphs>13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an Li</dc:creator>
  <cp:lastModifiedBy>Quan Li</cp:lastModifiedBy>
  <cp:revision>7</cp:revision>
  <dcterms:created xsi:type="dcterms:W3CDTF">2013-05-15T20:10:55Z</dcterms:created>
  <dcterms:modified xsi:type="dcterms:W3CDTF">2013-05-15T20:39:06Z</dcterms:modified>
</cp:coreProperties>
</file>